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7" r:id="rId2"/>
    <p:sldId id="271" r:id="rId3"/>
    <p:sldId id="273" r:id="rId4"/>
    <p:sldId id="275" r:id="rId5"/>
    <p:sldId id="274" r:id="rId6"/>
    <p:sldId id="272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000" autoAdjust="0"/>
    <p:restoredTop sz="94561"/>
  </p:normalViewPr>
  <p:slideViewPr>
    <p:cSldViewPr snapToGrid="0" showGuides="1">
      <p:cViewPr varScale="1">
        <p:scale>
          <a:sx n="82" d="100"/>
          <a:sy n="82" d="100"/>
        </p:scale>
        <p:origin x="672" y="5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9E03C8D-05AF-490D-9DA6-49EA86CB8B63}" type="datetimeFigureOut">
              <a:rPr lang="en-US" smtClean="0"/>
              <a:t>1/22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A210F4-AAEA-42F7-81C0-20FE0C1EA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50283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DA210F4-AAEA-42F7-81C0-20FE0C1EA987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573356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Figure S1</a:t>
            </a:r>
            <a:r>
              <a:rPr lang="en-US" dirty="0"/>
              <a:t>. Age distribution of the whole cohort of patients.</a:t>
            </a: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DA210F4-AAEA-42F7-81C0-20FE0C1EA987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568568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Figure S2</a:t>
            </a:r>
            <a:r>
              <a:rPr lang="en-US" dirty="0"/>
              <a:t>. </a:t>
            </a:r>
            <a:r>
              <a:rPr lang="it-IT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rain-site </a:t>
            </a:r>
            <a:r>
              <a:rPr lang="it-IT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istribution</a:t>
            </a:r>
            <a:r>
              <a:rPr lang="it-IT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of </a:t>
            </a:r>
            <a:r>
              <a:rPr lang="it-IT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glioblastomas</a:t>
            </a:r>
            <a:r>
              <a:rPr lang="it-IT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for the </a:t>
            </a:r>
            <a:r>
              <a:rPr lang="it-IT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entire</a:t>
            </a:r>
            <a:r>
              <a:rPr lang="it-IT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ohort</a:t>
            </a:r>
            <a:r>
              <a:rPr lang="it-IT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of </a:t>
            </a:r>
            <a:r>
              <a:rPr lang="it-IT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atients</a:t>
            </a:r>
            <a:r>
              <a:rPr lang="it-IT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endParaRPr lang="en-US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DA210F4-AAEA-42F7-81C0-20FE0C1EA987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83125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Figure S3</a:t>
            </a:r>
            <a:r>
              <a:rPr lang="en-US" dirty="0"/>
              <a:t>. </a:t>
            </a:r>
            <a:r>
              <a:rPr lang="pt-BR" b="0" i="0" dirty="0">
                <a:solidFill>
                  <a:srgbClr val="4D5156"/>
                </a:solidFill>
                <a:effectLst/>
                <a:latin typeface="arial" panose="020B0604020202020204" pitchFamily="34" charset="0"/>
              </a:rPr>
              <a:t>O(6)-methylguanine-DNA methyltransferase (MGMT)</a:t>
            </a:r>
            <a:r>
              <a:rPr lang="en-US" dirty="0"/>
              <a:t> promoter methylation status in the whole cohort of patients.</a:t>
            </a: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DA210F4-AAEA-42F7-81C0-20FE0C1EA987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175991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Figure S4</a:t>
            </a:r>
            <a:r>
              <a:rPr lang="en-US" dirty="0"/>
              <a:t>. Overall survival of: a. all patients; b. primary tumors versus recurrences</a:t>
            </a: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DA210F4-AAEA-42F7-81C0-20FE0C1EA987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33592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BE5E8-EE26-4F21-89BC-9EBDB4E11B1A}" type="datetimeFigureOut">
              <a:rPr lang="en-US" smtClean="0"/>
              <a:t>1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0774F-2E4B-4367-8A2B-A17DAC83B9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4769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BE5E8-EE26-4F21-89BC-9EBDB4E11B1A}" type="datetimeFigureOut">
              <a:rPr lang="en-US" smtClean="0"/>
              <a:t>1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0774F-2E4B-4367-8A2B-A17DAC83B9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52319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BE5E8-EE26-4F21-89BC-9EBDB4E11B1A}" type="datetimeFigureOut">
              <a:rPr lang="en-US" smtClean="0"/>
              <a:t>1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0774F-2E4B-4367-8A2B-A17DAC83B9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0202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BE5E8-EE26-4F21-89BC-9EBDB4E11B1A}" type="datetimeFigureOut">
              <a:rPr lang="en-US" smtClean="0"/>
              <a:t>1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0774F-2E4B-4367-8A2B-A17DAC83B9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03474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BE5E8-EE26-4F21-89BC-9EBDB4E11B1A}" type="datetimeFigureOut">
              <a:rPr lang="en-US" smtClean="0"/>
              <a:t>1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0774F-2E4B-4367-8A2B-A17DAC83B9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83758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BE5E8-EE26-4F21-89BC-9EBDB4E11B1A}" type="datetimeFigureOut">
              <a:rPr lang="en-US" smtClean="0"/>
              <a:t>1/2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0774F-2E4B-4367-8A2B-A17DAC83B9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65206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BE5E8-EE26-4F21-89BC-9EBDB4E11B1A}" type="datetimeFigureOut">
              <a:rPr lang="en-US" smtClean="0"/>
              <a:t>1/22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0774F-2E4B-4367-8A2B-A17DAC83B9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40093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BE5E8-EE26-4F21-89BC-9EBDB4E11B1A}" type="datetimeFigureOut">
              <a:rPr lang="en-US" smtClean="0"/>
              <a:t>1/22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0774F-2E4B-4367-8A2B-A17DAC83B9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13228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BE5E8-EE26-4F21-89BC-9EBDB4E11B1A}" type="datetimeFigureOut">
              <a:rPr lang="en-US" smtClean="0"/>
              <a:t>1/22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0774F-2E4B-4367-8A2B-A17DAC83B9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59615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BE5E8-EE26-4F21-89BC-9EBDB4E11B1A}" type="datetimeFigureOut">
              <a:rPr lang="en-US" smtClean="0"/>
              <a:t>1/2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0774F-2E4B-4367-8A2B-A17DAC83B9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61508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BE5E8-EE26-4F21-89BC-9EBDB4E11B1A}" type="datetimeFigureOut">
              <a:rPr lang="en-US" smtClean="0"/>
              <a:t>1/2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0774F-2E4B-4367-8A2B-A17DAC83B9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5322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1BE5E8-EE26-4F21-89BC-9EBDB4E11B1A}" type="datetimeFigureOut">
              <a:rPr lang="en-US" smtClean="0"/>
              <a:t>1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E0774F-2E4B-4367-8A2B-A17DAC83B9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03974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ry</a:t>
            </a:r>
          </a:p>
        </p:txBody>
      </p:sp>
    </p:spTree>
    <p:extLst>
      <p:ext uri="{BB962C8B-B14F-4D97-AF65-F5344CB8AC3E}">
        <p14:creationId xmlns:p14="http://schemas.microsoft.com/office/powerpoint/2010/main" val="8596430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E10DC4D4-3A9E-750B-B1C9-217FDCFE143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93570516"/>
              </p:ext>
            </p:extLst>
          </p:nvPr>
        </p:nvGraphicFramePr>
        <p:xfrm>
          <a:off x="2714626" y="1600201"/>
          <a:ext cx="6557963" cy="4400550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674075">
                  <a:extLst>
                    <a:ext uri="{9D8B030D-6E8A-4147-A177-3AD203B41FA5}">
                      <a16:colId xmlns:a16="http://schemas.microsoft.com/office/drawing/2014/main" val="816682447"/>
                    </a:ext>
                  </a:extLst>
                </a:gridCol>
                <a:gridCol w="980648">
                  <a:extLst>
                    <a:ext uri="{9D8B030D-6E8A-4147-A177-3AD203B41FA5}">
                      <a16:colId xmlns:a16="http://schemas.microsoft.com/office/drawing/2014/main" val="3034047796"/>
                    </a:ext>
                  </a:extLst>
                </a:gridCol>
                <a:gridCol w="980648">
                  <a:extLst>
                    <a:ext uri="{9D8B030D-6E8A-4147-A177-3AD203B41FA5}">
                      <a16:colId xmlns:a16="http://schemas.microsoft.com/office/drawing/2014/main" val="1070767468"/>
                    </a:ext>
                  </a:extLst>
                </a:gridCol>
                <a:gridCol w="980648">
                  <a:extLst>
                    <a:ext uri="{9D8B030D-6E8A-4147-A177-3AD203B41FA5}">
                      <a16:colId xmlns:a16="http://schemas.microsoft.com/office/drawing/2014/main" val="4092366407"/>
                    </a:ext>
                  </a:extLst>
                </a:gridCol>
                <a:gridCol w="980648">
                  <a:extLst>
                    <a:ext uri="{9D8B030D-6E8A-4147-A177-3AD203B41FA5}">
                      <a16:colId xmlns:a16="http://schemas.microsoft.com/office/drawing/2014/main" val="1240453763"/>
                    </a:ext>
                  </a:extLst>
                </a:gridCol>
                <a:gridCol w="980648">
                  <a:extLst>
                    <a:ext uri="{9D8B030D-6E8A-4147-A177-3AD203B41FA5}">
                      <a16:colId xmlns:a16="http://schemas.microsoft.com/office/drawing/2014/main" val="1513621035"/>
                    </a:ext>
                  </a:extLst>
                </a:gridCol>
                <a:gridCol w="980648">
                  <a:extLst>
                    <a:ext uri="{9D8B030D-6E8A-4147-A177-3AD203B41FA5}">
                      <a16:colId xmlns:a16="http://schemas.microsoft.com/office/drawing/2014/main" val="1098816946"/>
                    </a:ext>
                  </a:extLst>
                </a:gridCol>
              </a:tblGrid>
              <a:tr h="926432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ker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types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body Clone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any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lution 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uffer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tection and amplification system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7903654"/>
                  </a:ext>
                </a:extLst>
              </a:tr>
              <a:tr h="162125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ral T cell population; effector T cells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oclonal rabbit antibody, clone 2GV6 / Ref. Nr. 790-4341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ntana Medical Systems, Tucson, Arizona, USA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200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1 (</a:t>
                      </a:r>
                      <a:r>
                        <a:rPr lang="en-US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</a:t>
                      </a: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8), 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ntana Medical Systems, </a:t>
                      </a:r>
                      <a:r>
                        <a:rPr lang="en-GB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scon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USA)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ltraView</a:t>
                      </a: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AB, 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ntana Medical Systems, </a:t>
                      </a:r>
                      <a:r>
                        <a:rPr lang="en-GB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scon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USA)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635636248"/>
                  </a:ext>
                </a:extLst>
              </a:tr>
              <a:tr h="1852863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-L1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gen presenting cells, cancer cells, macrophages, neurons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oclonal rabbit antibody, Clone SP263 / Ref. Nr. 740-4907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ntana Medical Systems, Tucson, Arizona, USA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1 (</a:t>
                      </a:r>
                      <a:r>
                        <a:rPr lang="en-US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</a:t>
                      </a: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8), 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ntana Medical Systems, </a:t>
                      </a:r>
                      <a:r>
                        <a:rPr lang="en-GB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scon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USA)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ltraView</a:t>
                      </a: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AB, 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ntana Medical Systems, </a:t>
                      </a:r>
                      <a:r>
                        <a:rPr lang="en-GB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scon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USA)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4929016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EC61E009-B3E4-8FBE-3069-A630D3C07AF4}"/>
              </a:ext>
            </a:extLst>
          </p:cNvPr>
          <p:cNvSpPr txBox="1"/>
          <p:nvPr/>
        </p:nvSpPr>
        <p:spPr>
          <a:xfrm>
            <a:off x="2714626" y="754251"/>
            <a:ext cx="8615362" cy="3755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400" b="1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Supplemental Table S1</a:t>
            </a:r>
            <a:r>
              <a:rPr lang="en-US" sz="14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: Antibodies and immunostaining protocols.</a:t>
            </a:r>
            <a:endParaRPr lang="en-US" sz="1400" dirty="0">
              <a:effectLst/>
              <a:latin typeface="Cambria" panose="02040503050406030204" pitchFamily="18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24477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DA8BAFD9-2114-9AFF-915C-9193E352060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7900" y="71437"/>
            <a:ext cx="7696200" cy="67151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608892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A7A1093B-BAAD-3C63-D3A7-58612CEDAD5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7900" y="1476375"/>
            <a:ext cx="7696200" cy="3905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34924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B3E124C2-D557-9AC9-053A-6838B9E98D5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7900" y="71437"/>
            <a:ext cx="7696200" cy="67151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151724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uppo 12">
            <a:extLst>
              <a:ext uri="{FF2B5EF4-FFF2-40B4-BE49-F238E27FC236}">
                <a16:creationId xmlns:a16="http://schemas.microsoft.com/office/drawing/2014/main" id="{9C39C151-54D5-C997-E273-FA3388588DCE}"/>
              </a:ext>
            </a:extLst>
          </p:cNvPr>
          <p:cNvGrpSpPr/>
          <p:nvPr/>
        </p:nvGrpSpPr>
        <p:grpSpPr>
          <a:xfrm>
            <a:off x="2203160" y="1770015"/>
            <a:ext cx="7785680" cy="3317970"/>
            <a:chOff x="2203160" y="1701401"/>
            <a:chExt cx="7785680" cy="3317970"/>
          </a:xfrm>
        </p:grpSpPr>
        <p:pic>
          <p:nvPicPr>
            <p:cNvPr id="10" name="Immagine 9">
              <a:extLst>
                <a:ext uri="{FF2B5EF4-FFF2-40B4-BE49-F238E27FC236}">
                  <a16:creationId xmlns:a16="http://schemas.microsoft.com/office/drawing/2014/main" id="{21B97BEF-E80A-6CB5-DA98-0118A7FFE58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03160" y="1701401"/>
              <a:ext cx="3960000" cy="3317970"/>
            </a:xfrm>
            <a:prstGeom prst="rect">
              <a:avLst/>
            </a:prstGeom>
          </p:spPr>
        </p:pic>
        <p:pic>
          <p:nvPicPr>
            <p:cNvPr id="12" name="Immagine 11">
              <a:extLst>
                <a:ext uri="{FF2B5EF4-FFF2-40B4-BE49-F238E27FC236}">
                  <a16:creationId xmlns:a16="http://schemas.microsoft.com/office/drawing/2014/main" id="{06D40E7A-581A-1684-8A67-81CCE26BCB7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28840" y="1701401"/>
              <a:ext cx="3960000" cy="3317970"/>
            </a:xfrm>
            <a:prstGeom prst="rect">
              <a:avLst/>
            </a:prstGeom>
          </p:spPr>
        </p:pic>
      </p:grp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AFF5CED6-9AC8-F1BF-8DD1-755FC08DDAB9}"/>
              </a:ext>
            </a:extLst>
          </p:cNvPr>
          <p:cNvSpPr txBox="1"/>
          <p:nvPr/>
        </p:nvSpPr>
        <p:spPr>
          <a:xfrm>
            <a:off x="2001678" y="1701401"/>
            <a:ext cx="2686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4E3D2240-2094-B10A-38BA-11A95F650576}"/>
              </a:ext>
            </a:extLst>
          </p:cNvPr>
          <p:cNvSpPr txBox="1"/>
          <p:nvPr/>
        </p:nvSpPr>
        <p:spPr>
          <a:xfrm>
            <a:off x="6028840" y="1701401"/>
            <a:ext cx="2686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1059691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895</TotalTime>
  <Words>209</Words>
  <Application>Microsoft Office PowerPoint</Application>
  <PresentationFormat>Widescreen</PresentationFormat>
  <Paragraphs>34</Paragraphs>
  <Slides>6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4" baseType="lpstr">
      <vt:lpstr>MS Mincho</vt:lpstr>
      <vt:lpstr>arial</vt:lpstr>
      <vt:lpstr>arial</vt:lpstr>
      <vt:lpstr>Calibri</vt:lpstr>
      <vt:lpstr>Calibri Light</vt:lpstr>
      <vt:lpstr>Cambria</vt:lpstr>
      <vt:lpstr>Times New Roman</vt:lpstr>
      <vt:lpstr>Office Theme</vt:lpstr>
      <vt:lpstr>supplementary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Baylor College of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bhani, Navid</dc:creator>
  <cp:lastModifiedBy>MDPI</cp:lastModifiedBy>
  <cp:revision>55</cp:revision>
  <dcterms:created xsi:type="dcterms:W3CDTF">2022-08-04T16:22:36Z</dcterms:created>
  <dcterms:modified xsi:type="dcterms:W3CDTF">2023-01-22T09:53:30Z</dcterms:modified>
</cp:coreProperties>
</file>